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29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72" y="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FBE595-043F-4257-95B3-55C40E451E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0FA43D-C5C2-4CD7-AD1D-F1E2F85309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497DA1-9665-49B9-AD1A-A5FE00990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DF333F-F67C-4086-8BF3-BECA35834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C50006-9451-46DE-AB6D-AA53FD4D1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703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EAC05-76A9-4549-9A77-1214FE20B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871B36-BBCD-4831-8120-BDA42F39D1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0164A-4B3E-42E9-BFB5-7AA5C481F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D87B4-43EF-4A0A-A626-369C12E3C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9DE3C7-ECDB-45CC-9BAD-D8E625EF3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494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648C68-08F7-42DC-8509-9B50C4EFF9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DF32E3-4E18-48C5-9B6B-4D94A11ECE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C0B757-7A55-4CC6-9277-E1C0986BB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1A007-0C17-4254-A82C-B076D5DBF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DB359-CA8F-4B4A-B2DA-45C79E5C6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969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D256C1-7312-4C54-8312-5C765BD178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166A8F-F973-42AC-B118-7C21361183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5DBFAC-3093-4602-9164-2B483CE98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F4AD83-17E4-4403-8174-1A659D41B1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9373A-FF6D-4BF9-A4A4-88485D576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198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DC110-306B-4BEA-96E9-78403954FA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1DECE8-0CF2-45F9-B536-E10573F127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393E16-66F1-4F71-AF4E-9482A1466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16CA71-D116-4207-ACA6-681887790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347A7-D5F6-4B0F-B863-E3BA74C6B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751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76C79E-122A-4324-9511-E24E37B624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5D2E5B-DBBA-45D9-9C8B-E9FE60BEB2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1C0143-48E7-4D54-837E-129DED4999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EB6213-136B-440B-9E33-6ABC06E19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566FC6-1FA5-4333-AA1C-A6F029440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48D9CA-664F-4A95-97B3-524EB1A6E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659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47501-A67C-479E-8850-D3C1D03582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2894F1-1C04-4DF5-AB41-17E7C27CAF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519356-E1AD-45C8-992A-331A8F98B5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C03A00-A400-4826-8D4A-76E52B2BAA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34E87C-C15A-4591-A2E6-DA797BC4CB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2EE3BF-3698-44AA-83D2-FF941A786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454E40-35C0-4D6B-9758-4546E6317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9C1CFC-960F-4BD1-BE90-596415DB2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183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1B2453-A282-4606-AC37-32D2ABE25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C7E520-A206-4861-B1F3-77BD80ED4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B014DD-F307-41F7-8C3B-15E04C9A8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9CDED0-0F43-4C7B-942E-2038186F7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674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9D5F0F-39BC-4617-B497-BAD776A6A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55A2DA-CB70-475F-9D25-F8DD3A1C3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B4BECB-53F3-4723-9E1B-52BD88A74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077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45267-A17A-4F49-A750-C8F9E9D67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C4EBB8-F64E-4841-B174-BB96B33B2C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D904E4-56C0-4BC4-9AD6-791D06464C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BE6482-4BB9-4197-B393-CEC67623B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36FA0B-84A0-479A-ACC9-CD1200E94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5469F7-0EC0-4829-A029-24B283803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584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E48F9-6C56-427F-A37C-86954F43F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936DE9-9C1F-41EE-BD9D-73AC720E1C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972459-3727-40BC-AB21-9AEBBE0ABE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F90A7F-ADEF-43B1-9CA2-9BD329589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2FA3F7-2121-4AE0-B633-0CCCF808D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682576-1356-4D59-942E-0007D91E8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329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4B9AF1-E8B6-4A42-B5BE-006CEB8D33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08B21B-0300-489D-9708-27DDC1096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C9D11F-7642-4566-BF36-6698AF1758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74390-B734-458A-ADBA-B63CFD35727C}" type="datetimeFigureOut">
              <a:rPr lang="en-US" smtClean="0"/>
              <a:t>3/1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F4891-1283-40D3-A1E4-414F01524C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BB8818-6047-47B7-8FC7-CFCE6C25B0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5A6661-1F00-423A-A869-F6C5FB592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028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svg"/><Relationship Id="rId5" Type="http://schemas.openxmlformats.org/officeDocument/2006/relationships/image" Target="../media/image4.png"/><Relationship Id="rId4" Type="http://schemas.openxmlformats.org/officeDocument/2006/relationships/image" Target="../media/image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29F238AA-42FE-449F-9A4D-D1BC51D34BF7}"/>
              </a:ext>
            </a:extLst>
          </p:cNvPr>
          <p:cNvCxnSpPr>
            <a:cxnSpLocks/>
          </p:cNvCxnSpPr>
          <p:nvPr/>
        </p:nvCxnSpPr>
        <p:spPr>
          <a:xfrm flipV="1">
            <a:off x="1998482" y="3245328"/>
            <a:ext cx="0" cy="1461156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56B66E42-85C4-40CF-96C5-0CCF6FE5EFAA}"/>
              </a:ext>
            </a:extLst>
          </p:cNvPr>
          <p:cNvCxnSpPr>
            <a:cxnSpLocks/>
          </p:cNvCxnSpPr>
          <p:nvPr/>
        </p:nvCxnSpPr>
        <p:spPr>
          <a:xfrm flipV="1">
            <a:off x="3272671" y="3245328"/>
            <a:ext cx="0" cy="1461156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C3DFA4C-0A43-4205-B4B7-454E5B607453}"/>
              </a:ext>
            </a:extLst>
          </p:cNvPr>
          <p:cNvCxnSpPr>
            <a:cxnSpLocks/>
          </p:cNvCxnSpPr>
          <p:nvPr/>
        </p:nvCxnSpPr>
        <p:spPr>
          <a:xfrm flipV="1">
            <a:off x="4556287" y="3245328"/>
            <a:ext cx="0" cy="1461156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A6CE4155-5FB3-420B-A8F5-97F7240F2D52}"/>
              </a:ext>
            </a:extLst>
          </p:cNvPr>
          <p:cNvCxnSpPr>
            <a:cxnSpLocks/>
          </p:cNvCxnSpPr>
          <p:nvPr/>
        </p:nvCxnSpPr>
        <p:spPr>
          <a:xfrm flipV="1">
            <a:off x="5821050" y="3245328"/>
            <a:ext cx="0" cy="1461156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83FB69DD-6C44-4EE3-B8D3-6A59AFD08537}"/>
              </a:ext>
            </a:extLst>
          </p:cNvPr>
          <p:cNvCxnSpPr>
            <a:cxnSpLocks/>
          </p:cNvCxnSpPr>
          <p:nvPr/>
        </p:nvCxnSpPr>
        <p:spPr>
          <a:xfrm flipH="1" flipV="1">
            <a:off x="829558" y="3394411"/>
            <a:ext cx="1" cy="1027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5A096ED2-FA05-4024-B9C6-243953D8EDC8}"/>
              </a:ext>
            </a:extLst>
          </p:cNvPr>
          <p:cNvCxnSpPr>
            <a:cxnSpLocks/>
          </p:cNvCxnSpPr>
          <p:nvPr/>
        </p:nvCxnSpPr>
        <p:spPr>
          <a:xfrm flipH="1">
            <a:off x="829559" y="3394411"/>
            <a:ext cx="6693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C52767C2-7BB0-4FFF-82EF-09EAA6DCA783}"/>
              </a:ext>
            </a:extLst>
          </p:cNvPr>
          <p:cNvCxnSpPr>
            <a:cxnSpLocks/>
          </p:cNvCxnSpPr>
          <p:nvPr/>
        </p:nvCxnSpPr>
        <p:spPr>
          <a:xfrm flipV="1">
            <a:off x="1498334" y="3394411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FD24310-2020-4147-94D3-58F00555A48C}"/>
              </a:ext>
            </a:extLst>
          </p:cNvPr>
          <p:cNvCxnSpPr>
            <a:cxnSpLocks/>
          </p:cNvCxnSpPr>
          <p:nvPr/>
        </p:nvCxnSpPr>
        <p:spPr>
          <a:xfrm flipH="1">
            <a:off x="923829" y="4310379"/>
            <a:ext cx="210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3E6028D1-A8AA-4E59-8639-738FD4A3600E}"/>
              </a:ext>
            </a:extLst>
          </p:cNvPr>
          <p:cNvCxnSpPr>
            <a:cxnSpLocks/>
          </p:cNvCxnSpPr>
          <p:nvPr/>
        </p:nvCxnSpPr>
        <p:spPr>
          <a:xfrm flipV="1">
            <a:off x="924868" y="4310383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8D18B81C-F8FF-407C-80FF-856617B3FA8F}"/>
              </a:ext>
            </a:extLst>
          </p:cNvPr>
          <p:cNvCxnSpPr>
            <a:cxnSpLocks/>
          </p:cNvCxnSpPr>
          <p:nvPr/>
        </p:nvCxnSpPr>
        <p:spPr>
          <a:xfrm flipV="1">
            <a:off x="1133830" y="4321378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DCA4914F-6E27-458A-AC41-BC8E78F8ACCD}"/>
              </a:ext>
            </a:extLst>
          </p:cNvPr>
          <p:cNvCxnSpPr>
            <a:cxnSpLocks/>
          </p:cNvCxnSpPr>
          <p:nvPr/>
        </p:nvCxnSpPr>
        <p:spPr>
          <a:xfrm flipH="1">
            <a:off x="1585276" y="3394411"/>
            <a:ext cx="210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4815F5A6-C66D-4C56-97F0-F4A244534939}"/>
              </a:ext>
            </a:extLst>
          </p:cNvPr>
          <p:cNvCxnSpPr>
            <a:cxnSpLocks/>
          </p:cNvCxnSpPr>
          <p:nvPr/>
        </p:nvCxnSpPr>
        <p:spPr>
          <a:xfrm flipV="1">
            <a:off x="1586315" y="3394415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16641A82-0902-4F61-9175-3D9CE3B8C142}"/>
              </a:ext>
            </a:extLst>
          </p:cNvPr>
          <p:cNvCxnSpPr>
            <a:cxnSpLocks/>
          </p:cNvCxnSpPr>
          <p:nvPr/>
        </p:nvCxnSpPr>
        <p:spPr>
          <a:xfrm flipV="1">
            <a:off x="1795277" y="3405411"/>
            <a:ext cx="0" cy="1016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70A163CB-6C6B-4153-95BB-586970289E55}"/>
              </a:ext>
            </a:extLst>
          </p:cNvPr>
          <p:cNvSpPr txBox="1"/>
          <p:nvPr/>
        </p:nvSpPr>
        <p:spPr>
          <a:xfrm>
            <a:off x="857645" y="3222216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****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CC61869-EA3D-47C7-A285-63EAB29877DF}"/>
              </a:ext>
            </a:extLst>
          </p:cNvPr>
          <p:cNvSpPr txBox="1"/>
          <p:nvPr/>
        </p:nvSpPr>
        <p:spPr>
          <a:xfrm>
            <a:off x="1484455" y="322221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^^^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88FC7E66-7040-4C79-A8BA-333CB1A37967}"/>
              </a:ext>
            </a:extLst>
          </p:cNvPr>
          <p:cNvCxnSpPr>
            <a:cxnSpLocks/>
          </p:cNvCxnSpPr>
          <p:nvPr/>
        </p:nvCxnSpPr>
        <p:spPr>
          <a:xfrm flipH="1" flipV="1">
            <a:off x="2122912" y="3383411"/>
            <a:ext cx="1" cy="1027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DAFD57CF-3CE4-4C1B-BF52-A09F828A15E7}"/>
              </a:ext>
            </a:extLst>
          </p:cNvPr>
          <p:cNvCxnSpPr>
            <a:cxnSpLocks/>
          </p:cNvCxnSpPr>
          <p:nvPr/>
        </p:nvCxnSpPr>
        <p:spPr>
          <a:xfrm flipH="1">
            <a:off x="2122913" y="3383411"/>
            <a:ext cx="6693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38B105FB-A171-4EBF-B6DC-381A15BDBF7B}"/>
              </a:ext>
            </a:extLst>
          </p:cNvPr>
          <p:cNvCxnSpPr>
            <a:cxnSpLocks/>
          </p:cNvCxnSpPr>
          <p:nvPr/>
        </p:nvCxnSpPr>
        <p:spPr>
          <a:xfrm flipV="1">
            <a:off x="2791688" y="3383411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F7E90E60-B48F-4101-9AB5-8CAC02541C33}"/>
              </a:ext>
            </a:extLst>
          </p:cNvPr>
          <p:cNvCxnSpPr>
            <a:cxnSpLocks/>
          </p:cNvCxnSpPr>
          <p:nvPr/>
        </p:nvCxnSpPr>
        <p:spPr>
          <a:xfrm flipH="1">
            <a:off x="2217183" y="4299379"/>
            <a:ext cx="210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0EAE9E39-533D-47BD-9FE3-D35432CD09CB}"/>
              </a:ext>
            </a:extLst>
          </p:cNvPr>
          <p:cNvCxnSpPr>
            <a:cxnSpLocks/>
          </p:cNvCxnSpPr>
          <p:nvPr/>
        </p:nvCxnSpPr>
        <p:spPr>
          <a:xfrm flipV="1">
            <a:off x="2218222" y="4299383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B5A93FB9-7F8E-4D65-B8E0-16620E409F86}"/>
              </a:ext>
            </a:extLst>
          </p:cNvPr>
          <p:cNvCxnSpPr>
            <a:cxnSpLocks/>
          </p:cNvCxnSpPr>
          <p:nvPr/>
        </p:nvCxnSpPr>
        <p:spPr>
          <a:xfrm flipV="1">
            <a:off x="2427184" y="4310378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E0A47582-D338-4220-86C5-C201EE6A4A5A}"/>
              </a:ext>
            </a:extLst>
          </p:cNvPr>
          <p:cNvCxnSpPr>
            <a:cxnSpLocks/>
          </p:cNvCxnSpPr>
          <p:nvPr/>
        </p:nvCxnSpPr>
        <p:spPr>
          <a:xfrm flipH="1">
            <a:off x="2878630" y="3383411"/>
            <a:ext cx="210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9B11C42B-D461-4A18-B1C6-C4682CA84061}"/>
              </a:ext>
            </a:extLst>
          </p:cNvPr>
          <p:cNvCxnSpPr>
            <a:cxnSpLocks/>
          </p:cNvCxnSpPr>
          <p:nvPr/>
        </p:nvCxnSpPr>
        <p:spPr>
          <a:xfrm flipV="1">
            <a:off x="2879669" y="3383415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393259A9-F9D3-4C9E-85BB-1F3FFD9E8638}"/>
              </a:ext>
            </a:extLst>
          </p:cNvPr>
          <p:cNvCxnSpPr>
            <a:cxnSpLocks/>
          </p:cNvCxnSpPr>
          <p:nvPr/>
        </p:nvCxnSpPr>
        <p:spPr>
          <a:xfrm flipV="1">
            <a:off x="3088631" y="3394411"/>
            <a:ext cx="0" cy="1016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0177DEC5-D2E2-4647-8369-4363C813B58B}"/>
              </a:ext>
            </a:extLst>
          </p:cNvPr>
          <p:cNvSpPr txBox="1"/>
          <p:nvPr/>
        </p:nvSpPr>
        <p:spPr>
          <a:xfrm>
            <a:off x="2227199" y="3217566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***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48B4449-BDAA-4C39-97DD-76E5246302AB}"/>
              </a:ext>
            </a:extLst>
          </p:cNvPr>
          <p:cNvSpPr txBox="1"/>
          <p:nvPr/>
        </p:nvSpPr>
        <p:spPr>
          <a:xfrm>
            <a:off x="2809559" y="321756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^^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BE6CDCF8-C5BD-450C-88B5-B36622B9E199}"/>
              </a:ext>
            </a:extLst>
          </p:cNvPr>
          <p:cNvCxnSpPr>
            <a:cxnSpLocks/>
          </p:cNvCxnSpPr>
          <p:nvPr/>
        </p:nvCxnSpPr>
        <p:spPr>
          <a:xfrm flipH="1" flipV="1">
            <a:off x="3410195" y="3383411"/>
            <a:ext cx="1" cy="1027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08EE2435-E299-4F1D-945D-0A0955F98F92}"/>
              </a:ext>
            </a:extLst>
          </p:cNvPr>
          <p:cNvCxnSpPr>
            <a:cxnSpLocks/>
          </p:cNvCxnSpPr>
          <p:nvPr/>
        </p:nvCxnSpPr>
        <p:spPr>
          <a:xfrm flipH="1">
            <a:off x="3410196" y="3383411"/>
            <a:ext cx="66930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DB14C9EC-09B6-4708-9964-E86F71EB792E}"/>
              </a:ext>
            </a:extLst>
          </p:cNvPr>
          <p:cNvCxnSpPr>
            <a:cxnSpLocks/>
          </p:cNvCxnSpPr>
          <p:nvPr/>
        </p:nvCxnSpPr>
        <p:spPr>
          <a:xfrm flipV="1">
            <a:off x="4078971" y="3383411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B1929E76-1188-4508-82AA-1E0481440522}"/>
              </a:ext>
            </a:extLst>
          </p:cNvPr>
          <p:cNvCxnSpPr>
            <a:cxnSpLocks/>
          </p:cNvCxnSpPr>
          <p:nvPr/>
        </p:nvCxnSpPr>
        <p:spPr>
          <a:xfrm flipH="1">
            <a:off x="3515755" y="4299379"/>
            <a:ext cx="210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22ECA1B9-0C5B-42C0-959F-EE2DC2CEF943}"/>
              </a:ext>
            </a:extLst>
          </p:cNvPr>
          <p:cNvCxnSpPr>
            <a:cxnSpLocks/>
          </p:cNvCxnSpPr>
          <p:nvPr/>
        </p:nvCxnSpPr>
        <p:spPr>
          <a:xfrm flipV="1">
            <a:off x="3505505" y="4299383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B0F71540-5DBF-43FD-B39C-D738B33CA3A7}"/>
              </a:ext>
            </a:extLst>
          </p:cNvPr>
          <p:cNvCxnSpPr>
            <a:cxnSpLocks/>
          </p:cNvCxnSpPr>
          <p:nvPr/>
        </p:nvCxnSpPr>
        <p:spPr>
          <a:xfrm flipV="1">
            <a:off x="3714467" y="4310378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2000D92E-27CB-46FD-ACC9-D48AD73C4F57}"/>
              </a:ext>
            </a:extLst>
          </p:cNvPr>
          <p:cNvCxnSpPr>
            <a:cxnSpLocks/>
          </p:cNvCxnSpPr>
          <p:nvPr/>
        </p:nvCxnSpPr>
        <p:spPr>
          <a:xfrm flipH="1">
            <a:off x="4165913" y="3383411"/>
            <a:ext cx="210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2A1F2C60-B60F-4AC6-AE23-33B4D59E2665}"/>
              </a:ext>
            </a:extLst>
          </p:cNvPr>
          <p:cNvCxnSpPr>
            <a:cxnSpLocks/>
          </p:cNvCxnSpPr>
          <p:nvPr/>
        </p:nvCxnSpPr>
        <p:spPr>
          <a:xfrm flipV="1">
            <a:off x="4166952" y="3383415"/>
            <a:ext cx="0" cy="1036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8C4A40A9-2283-47F6-8247-6055F056A3CC}"/>
              </a:ext>
            </a:extLst>
          </p:cNvPr>
          <p:cNvCxnSpPr>
            <a:cxnSpLocks/>
          </p:cNvCxnSpPr>
          <p:nvPr/>
        </p:nvCxnSpPr>
        <p:spPr>
          <a:xfrm flipV="1">
            <a:off x="4375914" y="3394412"/>
            <a:ext cx="0" cy="91596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465A845E-AC27-42F5-8CB6-D61F0CBE4F45}"/>
              </a:ext>
            </a:extLst>
          </p:cNvPr>
          <p:cNvSpPr txBox="1"/>
          <p:nvPr/>
        </p:nvSpPr>
        <p:spPr>
          <a:xfrm>
            <a:off x="3609732" y="321756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303CB55-0E50-45E3-917D-CCF482246113}"/>
              </a:ext>
            </a:extLst>
          </p:cNvPr>
          <p:cNvSpPr txBox="1"/>
          <p:nvPr/>
        </p:nvSpPr>
        <p:spPr>
          <a:xfrm>
            <a:off x="3982542" y="3211216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^^^^^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48268BE8-8A93-4155-90B5-A9E34CCAD167}"/>
              </a:ext>
            </a:extLst>
          </p:cNvPr>
          <p:cNvSpPr txBox="1"/>
          <p:nvPr/>
        </p:nvSpPr>
        <p:spPr>
          <a:xfrm>
            <a:off x="870658" y="4118384"/>
            <a:ext cx="3401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NS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74346FA-643B-4686-AE15-B503FCF60771}"/>
              </a:ext>
            </a:extLst>
          </p:cNvPr>
          <p:cNvSpPr txBox="1"/>
          <p:nvPr/>
        </p:nvSpPr>
        <p:spPr>
          <a:xfrm>
            <a:off x="2165118" y="4100615"/>
            <a:ext cx="3401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NS</a:t>
            </a:r>
          </a:p>
        </p:txBody>
      </p: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5CB00A58-F69E-4404-9E59-BA8F10B170EC}"/>
              </a:ext>
            </a:extLst>
          </p:cNvPr>
          <p:cNvCxnSpPr>
            <a:cxnSpLocks/>
          </p:cNvCxnSpPr>
          <p:nvPr/>
        </p:nvCxnSpPr>
        <p:spPr>
          <a:xfrm flipV="1">
            <a:off x="7113627" y="3226448"/>
            <a:ext cx="0" cy="1461156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FBA66ACF-96CC-417D-A729-69F89A232E10}"/>
              </a:ext>
            </a:extLst>
          </p:cNvPr>
          <p:cNvSpPr txBox="1"/>
          <p:nvPr/>
        </p:nvSpPr>
        <p:spPr>
          <a:xfrm>
            <a:off x="3457694" y="4118384"/>
            <a:ext cx="3401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NS</a:t>
            </a:r>
          </a:p>
        </p:txBody>
      </p:sp>
      <p:pic>
        <p:nvPicPr>
          <p:cNvPr id="164" name="Picture 163" descr="Icon&#10;&#10;Description automatically generated">
            <a:extLst>
              <a:ext uri="{FF2B5EF4-FFF2-40B4-BE49-F238E27FC236}">
                <a16:creationId xmlns:a16="http://schemas.microsoft.com/office/drawing/2014/main" id="{F40B77A3-198B-429E-A7E3-0305EA256B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56" y="2820820"/>
            <a:ext cx="8663224" cy="2559589"/>
          </a:xfrm>
          <a:prstGeom prst="rect">
            <a:avLst/>
          </a:prstGeom>
        </p:spPr>
      </p:pic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7B0E2FCF-AC4B-FE4D-A644-37F7B8A43271}"/>
              </a:ext>
            </a:extLst>
          </p:cNvPr>
          <p:cNvCxnSpPr>
            <a:cxnSpLocks/>
          </p:cNvCxnSpPr>
          <p:nvPr/>
        </p:nvCxnSpPr>
        <p:spPr>
          <a:xfrm>
            <a:off x="1519707" y="1567290"/>
            <a:ext cx="7424057" cy="18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5" name="Graphic 44" descr="Rat with solid fill">
            <a:extLst>
              <a:ext uri="{FF2B5EF4-FFF2-40B4-BE49-F238E27FC236}">
                <a16:creationId xmlns:a16="http://schemas.microsoft.com/office/drawing/2014/main" id="{8F755CE7-B882-F141-9C53-135A067706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58221" y="379512"/>
            <a:ext cx="650449" cy="650449"/>
          </a:xfrm>
          <a:prstGeom prst="rect">
            <a:avLst/>
          </a:prstGeom>
        </p:spPr>
      </p:pic>
      <p:pic>
        <p:nvPicPr>
          <p:cNvPr id="46" name="Graphic 45" descr="Rat with solid fill">
            <a:extLst>
              <a:ext uri="{FF2B5EF4-FFF2-40B4-BE49-F238E27FC236}">
                <a16:creationId xmlns:a16="http://schemas.microsoft.com/office/drawing/2014/main" id="{FAF794E7-85DB-E144-B9CA-EFA6B15844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58221" y="916841"/>
            <a:ext cx="650449" cy="650449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A5B5D89B-9915-AB4B-8C76-3B5F9B9BE329}"/>
              </a:ext>
            </a:extLst>
          </p:cNvPr>
          <p:cNvSpPr txBox="1"/>
          <p:nvPr/>
        </p:nvSpPr>
        <p:spPr>
          <a:xfrm rot="16200000">
            <a:off x="-145111" y="557926"/>
            <a:ext cx="633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/>
              <a:t>Vehicl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D8711AC-7C46-0F40-8AF7-E114CBF70183}"/>
              </a:ext>
            </a:extLst>
          </p:cNvPr>
          <p:cNvSpPr txBox="1"/>
          <p:nvPr/>
        </p:nvSpPr>
        <p:spPr>
          <a:xfrm rot="16200000">
            <a:off x="-12743" y="1111877"/>
            <a:ext cx="399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/>
              <a:t>LPS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70940052-A7C3-DE4A-8428-F611039F68C4}"/>
              </a:ext>
            </a:extLst>
          </p:cNvPr>
          <p:cNvCxnSpPr>
            <a:cxnSpLocks/>
          </p:cNvCxnSpPr>
          <p:nvPr/>
        </p:nvCxnSpPr>
        <p:spPr>
          <a:xfrm flipH="1">
            <a:off x="1156467" y="1567290"/>
            <a:ext cx="363240" cy="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1" name="Group 50">
            <a:extLst>
              <a:ext uri="{FF2B5EF4-FFF2-40B4-BE49-F238E27FC236}">
                <a16:creationId xmlns:a16="http://schemas.microsoft.com/office/drawing/2014/main" id="{ABD92B6C-63C6-A54A-96E5-E0E665377C74}"/>
              </a:ext>
            </a:extLst>
          </p:cNvPr>
          <p:cNvGrpSpPr/>
          <p:nvPr/>
        </p:nvGrpSpPr>
        <p:grpSpPr>
          <a:xfrm>
            <a:off x="982542" y="143223"/>
            <a:ext cx="1129006" cy="1419046"/>
            <a:chOff x="982542" y="-23879"/>
            <a:chExt cx="1129006" cy="1419046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6756D63-7706-324A-949E-78D20C8B423B}"/>
                </a:ext>
              </a:extLst>
            </p:cNvPr>
            <p:cNvSpPr txBox="1"/>
            <p:nvPr/>
          </p:nvSpPr>
          <p:spPr>
            <a:xfrm>
              <a:off x="982542" y="-23879"/>
              <a:ext cx="8451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u="sng" dirty="0"/>
                <a:t>Week 1</a:t>
              </a:r>
            </a:p>
            <a:p>
              <a:pPr algn="ctr"/>
              <a:r>
                <a:rPr lang="en-US" sz="1200" dirty="0"/>
                <a:t>Injection 1</a:t>
              </a:r>
            </a:p>
          </p:txBody>
        </p:sp>
        <p:pic>
          <p:nvPicPr>
            <p:cNvPr id="53" name="Graphic 52" descr="Needle with solid fill">
              <a:extLst>
                <a:ext uri="{FF2B5EF4-FFF2-40B4-BE49-F238E27FC236}">
                  <a16:creationId xmlns:a16="http://schemas.microsoft.com/office/drawing/2014/main" id="{38690590-41BC-5949-8E85-92C35FE6BE2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654348" y="85954"/>
              <a:ext cx="457200" cy="457200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D87FEB8-D222-9C4D-96B3-8A53546275E3}"/>
                </a:ext>
              </a:extLst>
            </p:cNvPr>
            <p:cNvSpPr txBox="1"/>
            <p:nvPr/>
          </p:nvSpPr>
          <p:spPr>
            <a:xfrm>
              <a:off x="1156467" y="979029"/>
              <a:ext cx="7264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4mg/kg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0942FB40-4562-6E48-B8D6-C1AD1799173E}"/>
                </a:ext>
              </a:extLst>
            </p:cNvPr>
            <p:cNvCxnSpPr>
              <a:stCxn id="54" idx="2"/>
            </p:cNvCxnSpPr>
            <p:nvPr/>
          </p:nvCxnSpPr>
          <p:spPr>
            <a:xfrm flipH="1">
              <a:off x="1519707" y="1240639"/>
              <a:ext cx="1" cy="154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9340E5BA-2872-7A41-A56E-642A342F0842}"/>
              </a:ext>
            </a:extLst>
          </p:cNvPr>
          <p:cNvCxnSpPr>
            <a:cxnSpLocks/>
          </p:cNvCxnSpPr>
          <p:nvPr/>
        </p:nvCxnSpPr>
        <p:spPr>
          <a:xfrm flipV="1">
            <a:off x="1432357" y="1614423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7" name="Group 56">
            <a:extLst>
              <a:ext uri="{FF2B5EF4-FFF2-40B4-BE49-F238E27FC236}">
                <a16:creationId xmlns:a16="http://schemas.microsoft.com/office/drawing/2014/main" id="{242C81AD-3E63-4E47-BBF5-E621063A65B0}"/>
              </a:ext>
            </a:extLst>
          </p:cNvPr>
          <p:cNvGrpSpPr/>
          <p:nvPr/>
        </p:nvGrpSpPr>
        <p:grpSpPr>
          <a:xfrm>
            <a:off x="2246188" y="143223"/>
            <a:ext cx="1129006" cy="1419046"/>
            <a:chOff x="982542" y="-23879"/>
            <a:chExt cx="1129006" cy="1419046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8F0DFA0-711D-314A-B6A6-F4B6748A59E3}"/>
                </a:ext>
              </a:extLst>
            </p:cNvPr>
            <p:cNvSpPr txBox="1"/>
            <p:nvPr/>
          </p:nvSpPr>
          <p:spPr>
            <a:xfrm>
              <a:off x="982542" y="-23879"/>
              <a:ext cx="8451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u="sng" dirty="0"/>
                <a:t>Week 3</a:t>
              </a:r>
            </a:p>
            <a:p>
              <a:pPr algn="ctr"/>
              <a:r>
                <a:rPr lang="en-US" sz="1200" dirty="0"/>
                <a:t>Injection 2</a:t>
              </a:r>
            </a:p>
          </p:txBody>
        </p:sp>
        <p:pic>
          <p:nvPicPr>
            <p:cNvPr id="59" name="Graphic 58" descr="Needle with solid fill">
              <a:extLst>
                <a:ext uri="{FF2B5EF4-FFF2-40B4-BE49-F238E27FC236}">
                  <a16:creationId xmlns:a16="http://schemas.microsoft.com/office/drawing/2014/main" id="{1D02981D-BED0-E948-A9B8-CDBFA883CE5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654348" y="85954"/>
              <a:ext cx="457200" cy="457200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A117C05-2048-0F4E-8B58-DCA3A51A8E99}"/>
                </a:ext>
              </a:extLst>
            </p:cNvPr>
            <p:cNvSpPr txBox="1"/>
            <p:nvPr/>
          </p:nvSpPr>
          <p:spPr>
            <a:xfrm>
              <a:off x="1156467" y="979029"/>
              <a:ext cx="7264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4mg/kg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1B50686C-6AB5-184F-851A-2C5982797A4A}"/>
                </a:ext>
              </a:extLst>
            </p:cNvPr>
            <p:cNvCxnSpPr>
              <a:stCxn id="60" idx="2"/>
            </p:cNvCxnSpPr>
            <p:nvPr/>
          </p:nvCxnSpPr>
          <p:spPr>
            <a:xfrm>
              <a:off x="1519708" y="1240639"/>
              <a:ext cx="0" cy="154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9E1CECD2-2044-E144-99C4-65D4322D1830}"/>
              </a:ext>
            </a:extLst>
          </p:cNvPr>
          <p:cNvGrpSpPr/>
          <p:nvPr/>
        </p:nvGrpSpPr>
        <p:grpSpPr>
          <a:xfrm>
            <a:off x="3495977" y="143223"/>
            <a:ext cx="1129006" cy="1419046"/>
            <a:chOff x="982542" y="-23879"/>
            <a:chExt cx="1129006" cy="1419046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3108811-E202-B746-A4D9-E49495F5DA71}"/>
                </a:ext>
              </a:extLst>
            </p:cNvPr>
            <p:cNvSpPr txBox="1"/>
            <p:nvPr/>
          </p:nvSpPr>
          <p:spPr>
            <a:xfrm>
              <a:off x="982542" y="-23879"/>
              <a:ext cx="8451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u="sng" dirty="0"/>
                <a:t>Week 5</a:t>
              </a:r>
            </a:p>
            <a:p>
              <a:pPr algn="ctr"/>
              <a:r>
                <a:rPr lang="en-US" sz="1200" dirty="0"/>
                <a:t>Injection 3</a:t>
              </a:r>
            </a:p>
          </p:txBody>
        </p:sp>
        <p:pic>
          <p:nvPicPr>
            <p:cNvPr id="64" name="Graphic 63" descr="Needle with solid fill">
              <a:extLst>
                <a:ext uri="{FF2B5EF4-FFF2-40B4-BE49-F238E27FC236}">
                  <a16:creationId xmlns:a16="http://schemas.microsoft.com/office/drawing/2014/main" id="{A3C58BCD-02D9-564B-9693-979822D74FD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654348" y="85954"/>
              <a:ext cx="457200" cy="457200"/>
            </a:xfrm>
            <a:prstGeom prst="rect">
              <a:avLst/>
            </a:prstGeom>
          </p:spPr>
        </p:pic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FE54EED-09BC-BB4B-A902-6B0C81979EF8}"/>
                </a:ext>
              </a:extLst>
            </p:cNvPr>
            <p:cNvSpPr txBox="1"/>
            <p:nvPr/>
          </p:nvSpPr>
          <p:spPr>
            <a:xfrm>
              <a:off x="1156467" y="979029"/>
              <a:ext cx="7264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4mg/kg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BD142546-E57B-EA46-9C77-500DAAEA1004}"/>
                </a:ext>
              </a:extLst>
            </p:cNvPr>
            <p:cNvCxnSpPr>
              <a:stCxn id="65" idx="2"/>
            </p:cNvCxnSpPr>
            <p:nvPr/>
          </p:nvCxnSpPr>
          <p:spPr>
            <a:xfrm>
              <a:off x="1519708" y="1240639"/>
              <a:ext cx="0" cy="154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95C8651F-3656-4A4D-B399-22824391DCF4}"/>
              </a:ext>
            </a:extLst>
          </p:cNvPr>
          <p:cNvGrpSpPr/>
          <p:nvPr/>
        </p:nvGrpSpPr>
        <p:grpSpPr>
          <a:xfrm>
            <a:off x="4708788" y="143223"/>
            <a:ext cx="1129006" cy="1419046"/>
            <a:chOff x="982542" y="-23879"/>
            <a:chExt cx="1129006" cy="1419046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E5CF880-9512-644F-B62B-2660F3F5A34F}"/>
                </a:ext>
              </a:extLst>
            </p:cNvPr>
            <p:cNvSpPr txBox="1"/>
            <p:nvPr/>
          </p:nvSpPr>
          <p:spPr>
            <a:xfrm>
              <a:off x="982542" y="-23879"/>
              <a:ext cx="8451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u="sng" dirty="0"/>
                <a:t>Week 7</a:t>
              </a:r>
            </a:p>
            <a:p>
              <a:pPr algn="ctr"/>
              <a:r>
                <a:rPr lang="en-US" sz="1200" dirty="0"/>
                <a:t>Injection 4</a:t>
              </a:r>
            </a:p>
          </p:txBody>
        </p:sp>
        <p:pic>
          <p:nvPicPr>
            <p:cNvPr id="69" name="Graphic 68" descr="Needle with solid fill">
              <a:extLst>
                <a:ext uri="{FF2B5EF4-FFF2-40B4-BE49-F238E27FC236}">
                  <a16:creationId xmlns:a16="http://schemas.microsoft.com/office/drawing/2014/main" id="{318A1738-804A-EB4D-9894-2125A749B07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654348" y="85954"/>
              <a:ext cx="457200" cy="457200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6B9D52DF-4C69-BC4C-A2B1-DA26B0E7A6DF}"/>
                </a:ext>
              </a:extLst>
            </p:cNvPr>
            <p:cNvSpPr txBox="1"/>
            <p:nvPr/>
          </p:nvSpPr>
          <p:spPr>
            <a:xfrm>
              <a:off x="1156467" y="979029"/>
              <a:ext cx="7264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4mg/kg</a:t>
              </a:r>
            </a:p>
          </p:txBody>
        </p: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604CE766-B124-B148-AA7D-1AD51DCA751D}"/>
                </a:ext>
              </a:extLst>
            </p:cNvPr>
            <p:cNvCxnSpPr>
              <a:stCxn id="70" idx="2"/>
            </p:cNvCxnSpPr>
            <p:nvPr/>
          </p:nvCxnSpPr>
          <p:spPr>
            <a:xfrm>
              <a:off x="1519708" y="1240639"/>
              <a:ext cx="0" cy="154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713D0B4D-5825-864B-95ED-2CD26DCAE01E}"/>
              </a:ext>
            </a:extLst>
          </p:cNvPr>
          <p:cNvGrpSpPr/>
          <p:nvPr/>
        </p:nvGrpSpPr>
        <p:grpSpPr>
          <a:xfrm>
            <a:off x="5956152" y="143223"/>
            <a:ext cx="1129006" cy="1419046"/>
            <a:chOff x="982542" y="-23879"/>
            <a:chExt cx="1129006" cy="1419046"/>
          </a:xfrm>
        </p:grpSpPr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205FB0E8-BF33-5946-A420-46BC59D3E513}"/>
                </a:ext>
              </a:extLst>
            </p:cNvPr>
            <p:cNvSpPr txBox="1"/>
            <p:nvPr/>
          </p:nvSpPr>
          <p:spPr>
            <a:xfrm>
              <a:off x="982542" y="-23879"/>
              <a:ext cx="84510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u="sng" dirty="0"/>
                <a:t>Week 9</a:t>
              </a:r>
            </a:p>
            <a:p>
              <a:pPr algn="ctr"/>
              <a:r>
                <a:rPr lang="en-US" sz="1200" dirty="0"/>
                <a:t>Injection 5</a:t>
              </a:r>
            </a:p>
          </p:txBody>
        </p:sp>
        <p:pic>
          <p:nvPicPr>
            <p:cNvPr id="111" name="Graphic 110" descr="Needle with solid fill">
              <a:extLst>
                <a:ext uri="{FF2B5EF4-FFF2-40B4-BE49-F238E27FC236}">
                  <a16:creationId xmlns:a16="http://schemas.microsoft.com/office/drawing/2014/main" id="{BC34C248-94B3-2948-AFEF-5143696588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654348" y="85954"/>
              <a:ext cx="457200" cy="457200"/>
            </a:xfrm>
            <a:prstGeom prst="rect">
              <a:avLst/>
            </a:prstGeom>
          </p:spPr>
        </p:pic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A1B88F66-5F67-FA4D-81F5-05F3100F8A2F}"/>
                </a:ext>
              </a:extLst>
            </p:cNvPr>
            <p:cNvSpPr txBox="1"/>
            <p:nvPr/>
          </p:nvSpPr>
          <p:spPr>
            <a:xfrm>
              <a:off x="1156467" y="979029"/>
              <a:ext cx="7264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4mg/kg</a:t>
              </a:r>
            </a:p>
          </p:txBody>
        </p: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3DA6BEEB-A463-6F47-8999-3FA7CD7EA329}"/>
                </a:ext>
              </a:extLst>
            </p:cNvPr>
            <p:cNvCxnSpPr>
              <a:stCxn id="112" idx="2"/>
            </p:cNvCxnSpPr>
            <p:nvPr/>
          </p:nvCxnSpPr>
          <p:spPr>
            <a:xfrm>
              <a:off x="1519708" y="1240639"/>
              <a:ext cx="0" cy="154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43D0C663-BEA2-774B-8F71-1D1B8F2B6ABC}"/>
              </a:ext>
            </a:extLst>
          </p:cNvPr>
          <p:cNvSpPr txBox="1"/>
          <p:nvPr/>
        </p:nvSpPr>
        <p:spPr>
          <a:xfrm>
            <a:off x="8410627" y="1048236"/>
            <a:ext cx="113524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Tissue Collection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7BC8A086-5033-8444-9642-9354E87BBC3A}"/>
              </a:ext>
            </a:extLst>
          </p:cNvPr>
          <p:cNvCxnSpPr>
            <a:cxnSpLocks/>
          </p:cNvCxnSpPr>
          <p:nvPr/>
        </p:nvCxnSpPr>
        <p:spPr>
          <a:xfrm>
            <a:off x="8943764" y="1427301"/>
            <a:ext cx="0" cy="15452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B93C69EE-A943-834E-AA2F-2C52F762FF3D}"/>
              </a:ext>
            </a:extLst>
          </p:cNvPr>
          <p:cNvSpPr txBox="1"/>
          <p:nvPr/>
        </p:nvSpPr>
        <p:spPr>
          <a:xfrm>
            <a:off x="1220651" y="1792105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9C29B72D-6F40-4144-A9A9-201F7359C870}"/>
              </a:ext>
            </a:extLst>
          </p:cNvPr>
          <p:cNvCxnSpPr>
            <a:cxnSpLocks/>
          </p:cNvCxnSpPr>
          <p:nvPr/>
        </p:nvCxnSpPr>
        <p:spPr>
          <a:xfrm flipV="1">
            <a:off x="1593043" y="1613837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D39B0653-4C6B-CE48-934B-61BD5732C7F0}"/>
              </a:ext>
            </a:extLst>
          </p:cNvPr>
          <p:cNvCxnSpPr>
            <a:cxnSpLocks/>
          </p:cNvCxnSpPr>
          <p:nvPr/>
        </p:nvCxnSpPr>
        <p:spPr>
          <a:xfrm flipV="1">
            <a:off x="2707095" y="1599851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DF15C004-57E0-3247-8C83-07CFC03A7FC2}"/>
              </a:ext>
            </a:extLst>
          </p:cNvPr>
          <p:cNvSpPr txBox="1"/>
          <p:nvPr/>
        </p:nvSpPr>
        <p:spPr>
          <a:xfrm>
            <a:off x="2495389" y="1777533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800E07A6-3CF9-F94B-B435-2931EA4F7259}"/>
              </a:ext>
            </a:extLst>
          </p:cNvPr>
          <p:cNvCxnSpPr>
            <a:cxnSpLocks/>
          </p:cNvCxnSpPr>
          <p:nvPr/>
        </p:nvCxnSpPr>
        <p:spPr>
          <a:xfrm flipV="1">
            <a:off x="2867781" y="1599265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1A3745DC-94CB-4442-9F9C-EEB481909411}"/>
              </a:ext>
            </a:extLst>
          </p:cNvPr>
          <p:cNvCxnSpPr>
            <a:cxnSpLocks/>
          </p:cNvCxnSpPr>
          <p:nvPr/>
        </p:nvCxnSpPr>
        <p:spPr>
          <a:xfrm flipV="1">
            <a:off x="3960018" y="1601996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C243CCCF-F0A4-6249-BD04-7F9AA6A8FF6D}"/>
              </a:ext>
            </a:extLst>
          </p:cNvPr>
          <p:cNvSpPr txBox="1"/>
          <p:nvPr/>
        </p:nvSpPr>
        <p:spPr>
          <a:xfrm>
            <a:off x="3748312" y="1779678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DCCAD118-0B92-5E40-9C0C-A61000D35DF3}"/>
              </a:ext>
            </a:extLst>
          </p:cNvPr>
          <p:cNvCxnSpPr>
            <a:cxnSpLocks/>
          </p:cNvCxnSpPr>
          <p:nvPr/>
        </p:nvCxnSpPr>
        <p:spPr>
          <a:xfrm flipV="1">
            <a:off x="4120704" y="1601410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21CEC0FE-5C1A-0B4B-97AE-A3A3994E27F9}"/>
              </a:ext>
            </a:extLst>
          </p:cNvPr>
          <p:cNvCxnSpPr>
            <a:cxnSpLocks/>
          </p:cNvCxnSpPr>
          <p:nvPr/>
        </p:nvCxnSpPr>
        <p:spPr>
          <a:xfrm flipV="1">
            <a:off x="5175308" y="1598527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0FF2B2BB-59D3-EF45-816E-0A9688FCD2E1}"/>
              </a:ext>
            </a:extLst>
          </p:cNvPr>
          <p:cNvSpPr txBox="1"/>
          <p:nvPr/>
        </p:nvSpPr>
        <p:spPr>
          <a:xfrm>
            <a:off x="4963602" y="1776209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D9948E9F-6804-BF4B-A3C1-59ACDC6AEDAB}"/>
              </a:ext>
            </a:extLst>
          </p:cNvPr>
          <p:cNvCxnSpPr>
            <a:cxnSpLocks/>
          </p:cNvCxnSpPr>
          <p:nvPr/>
        </p:nvCxnSpPr>
        <p:spPr>
          <a:xfrm flipV="1">
            <a:off x="5335994" y="1597941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9201D92C-61B1-1D46-A867-57F5D90D3677}"/>
              </a:ext>
            </a:extLst>
          </p:cNvPr>
          <p:cNvCxnSpPr>
            <a:cxnSpLocks/>
          </p:cNvCxnSpPr>
          <p:nvPr/>
        </p:nvCxnSpPr>
        <p:spPr>
          <a:xfrm flipV="1">
            <a:off x="6433854" y="1615747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D8E11F08-6265-144F-8E8F-5DDE65B4CC96}"/>
              </a:ext>
            </a:extLst>
          </p:cNvPr>
          <p:cNvSpPr txBox="1"/>
          <p:nvPr/>
        </p:nvSpPr>
        <p:spPr>
          <a:xfrm>
            <a:off x="6222148" y="1793429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F791C93E-85F8-B349-85DC-43735ADFEB7B}"/>
              </a:ext>
            </a:extLst>
          </p:cNvPr>
          <p:cNvCxnSpPr>
            <a:cxnSpLocks/>
          </p:cNvCxnSpPr>
          <p:nvPr/>
        </p:nvCxnSpPr>
        <p:spPr>
          <a:xfrm flipV="1">
            <a:off x="6594540" y="1615161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Straight Arrow Connector 139">
            <a:extLst>
              <a:ext uri="{FF2B5EF4-FFF2-40B4-BE49-F238E27FC236}">
                <a16:creationId xmlns:a16="http://schemas.microsoft.com/office/drawing/2014/main" id="{19D3A973-0A50-0141-8949-75842C726BCD}"/>
              </a:ext>
            </a:extLst>
          </p:cNvPr>
          <p:cNvCxnSpPr>
            <a:cxnSpLocks/>
          </p:cNvCxnSpPr>
          <p:nvPr/>
        </p:nvCxnSpPr>
        <p:spPr>
          <a:xfrm flipV="1">
            <a:off x="8918546" y="1614423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A3FE7C07-ECAF-6240-8500-D2D6A52C6FE9}"/>
              </a:ext>
            </a:extLst>
          </p:cNvPr>
          <p:cNvSpPr txBox="1"/>
          <p:nvPr/>
        </p:nvSpPr>
        <p:spPr>
          <a:xfrm>
            <a:off x="8706840" y="1792105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grpSp>
        <p:nvGrpSpPr>
          <p:cNvPr id="149" name="Group 148">
            <a:extLst>
              <a:ext uri="{FF2B5EF4-FFF2-40B4-BE49-F238E27FC236}">
                <a16:creationId xmlns:a16="http://schemas.microsoft.com/office/drawing/2014/main" id="{D8B7C639-9891-6E4D-AB53-6B3B2FCE5A9C}"/>
              </a:ext>
            </a:extLst>
          </p:cNvPr>
          <p:cNvGrpSpPr/>
          <p:nvPr/>
        </p:nvGrpSpPr>
        <p:grpSpPr>
          <a:xfrm>
            <a:off x="7103286" y="143223"/>
            <a:ext cx="1167029" cy="1419046"/>
            <a:chOff x="944519" y="-23879"/>
            <a:chExt cx="1167029" cy="1419046"/>
          </a:xfrm>
        </p:grpSpPr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54C62E11-EA26-0845-AA25-DD26D6CD72F4}"/>
                </a:ext>
              </a:extLst>
            </p:cNvPr>
            <p:cNvSpPr txBox="1"/>
            <p:nvPr/>
          </p:nvSpPr>
          <p:spPr>
            <a:xfrm>
              <a:off x="944519" y="-23879"/>
              <a:ext cx="9211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u="sng" dirty="0"/>
                <a:t>Week 11</a:t>
              </a:r>
            </a:p>
            <a:p>
              <a:pPr algn="ctr"/>
              <a:r>
                <a:rPr lang="en-US" sz="1200" dirty="0"/>
                <a:t>Injection 6</a:t>
              </a:r>
            </a:p>
          </p:txBody>
        </p:sp>
        <p:pic>
          <p:nvPicPr>
            <p:cNvPr id="151" name="Graphic 150" descr="Needle with solid fill">
              <a:extLst>
                <a:ext uri="{FF2B5EF4-FFF2-40B4-BE49-F238E27FC236}">
                  <a16:creationId xmlns:a16="http://schemas.microsoft.com/office/drawing/2014/main" id="{9AEE6EEE-ADFF-6043-ACCF-D09D411E565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654348" y="85954"/>
              <a:ext cx="457200" cy="457200"/>
            </a:xfrm>
            <a:prstGeom prst="rect">
              <a:avLst/>
            </a:prstGeom>
          </p:spPr>
        </p:pic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A93DA672-3B19-634F-A0FB-265092C022C0}"/>
                </a:ext>
              </a:extLst>
            </p:cNvPr>
            <p:cNvSpPr txBox="1"/>
            <p:nvPr/>
          </p:nvSpPr>
          <p:spPr>
            <a:xfrm>
              <a:off x="1156467" y="979029"/>
              <a:ext cx="7264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0.4mg/kg</a:t>
              </a:r>
            </a:p>
          </p:txBody>
        </p: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E89656B6-81FF-6E4D-B3E1-00039095DCC8}"/>
                </a:ext>
              </a:extLst>
            </p:cNvPr>
            <p:cNvCxnSpPr>
              <a:stCxn id="152" idx="2"/>
            </p:cNvCxnSpPr>
            <p:nvPr/>
          </p:nvCxnSpPr>
          <p:spPr>
            <a:xfrm>
              <a:off x="1519708" y="1240639"/>
              <a:ext cx="0" cy="154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E612DB4A-FDB0-5841-A49A-62DE47F6172E}"/>
              </a:ext>
            </a:extLst>
          </p:cNvPr>
          <p:cNvCxnSpPr>
            <a:cxnSpLocks/>
          </p:cNvCxnSpPr>
          <p:nvPr/>
        </p:nvCxnSpPr>
        <p:spPr>
          <a:xfrm flipV="1">
            <a:off x="7619011" y="1607060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AED5C707-5483-2940-8254-A39C21F6CBBD}"/>
              </a:ext>
            </a:extLst>
          </p:cNvPr>
          <p:cNvSpPr txBox="1"/>
          <p:nvPr/>
        </p:nvSpPr>
        <p:spPr>
          <a:xfrm>
            <a:off x="7407305" y="1784742"/>
            <a:ext cx="63166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Health Screen </a:t>
            </a:r>
          </a:p>
        </p:txBody>
      </p:sp>
      <p:cxnSp>
        <p:nvCxnSpPr>
          <p:cNvPr id="156" name="Straight Arrow Connector 155">
            <a:extLst>
              <a:ext uri="{FF2B5EF4-FFF2-40B4-BE49-F238E27FC236}">
                <a16:creationId xmlns:a16="http://schemas.microsoft.com/office/drawing/2014/main" id="{C33CF70B-F6ED-FD45-A523-2C8652ECEB80}"/>
              </a:ext>
            </a:extLst>
          </p:cNvPr>
          <p:cNvCxnSpPr>
            <a:cxnSpLocks/>
          </p:cNvCxnSpPr>
          <p:nvPr/>
        </p:nvCxnSpPr>
        <p:spPr>
          <a:xfrm flipV="1">
            <a:off x="7779697" y="1606474"/>
            <a:ext cx="0" cy="2305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1634236E-35A6-DB49-9040-539B9FE3AAC8}"/>
              </a:ext>
            </a:extLst>
          </p:cNvPr>
          <p:cNvSpPr txBox="1"/>
          <p:nvPr/>
        </p:nvSpPr>
        <p:spPr>
          <a:xfrm>
            <a:off x="0" y="1613837"/>
            <a:ext cx="10395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15 month </a:t>
            </a:r>
            <a:r>
              <a:rPr lang="en-US" sz="1100"/>
              <a:t>Male C57BL6</a:t>
            </a:r>
            <a:endParaRPr lang="en-US" sz="11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D57B9F3-408D-004E-9056-7205F84AE779}"/>
              </a:ext>
            </a:extLst>
          </p:cNvPr>
          <p:cNvSpPr txBox="1"/>
          <p:nvPr/>
        </p:nvSpPr>
        <p:spPr>
          <a:xfrm>
            <a:off x="8326466" y="143223"/>
            <a:ext cx="921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u="sng" dirty="0"/>
              <a:t>Week 13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9B88F003-ABB6-EA4F-997E-9FB894776F91}"/>
              </a:ext>
            </a:extLst>
          </p:cNvPr>
          <p:cNvCxnSpPr>
            <a:cxnSpLocks/>
          </p:cNvCxnSpPr>
          <p:nvPr/>
        </p:nvCxnSpPr>
        <p:spPr>
          <a:xfrm>
            <a:off x="1535255" y="3593054"/>
            <a:ext cx="6441047" cy="0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8510DD65-381E-1944-8B0F-E6D730FFB642}"/>
              </a:ext>
            </a:extLst>
          </p:cNvPr>
          <p:cNvCxnSpPr>
            <a:cxnSpLocks/>
          </p:cNvCxnSpPr>
          <p:nvPr/>
        </p:nvCxnSpPr>
        <p:spPr>
          <a:xfrm>
            <a:off x="2834959" y="3593054"/>
            <a:ext cx="0" cy="507560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D89001F1-8D2F-0A47-94A6-A8EDA585AEB8}"/>
              </a:ext>
            </a:extLst>
          </p:cNvPr>
          <p:cNvCxnSpPr>
            <a:cxnSpLocks/>
          </p:cNvCxnSpPr>
          <p:nvPr/>
        </p:nvCxnSpPr>
        <p:spPr>
          <a:xfrm>
            <a:off x="4120704" y="3593054"/>
            <a:ext cx="0" cy="458246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489E55E7-AE2A-EB45-B8AE-2B1CE3D87EEF}"/>
              </a:ext>
            </a:extLst>
          </p:cNvPr>
          <p:cNvCxnSpPr>
            <a:cxnSpLocks/>
          </p:cNvCxnSpPr>
          <p:nvPr/>
        </p:nvCxnSpPr>
        <p:spPr>
          <a:xfrm>
            <a:off x="5380594" y="3584975"/>
            <a:ext cx="0" cy="664214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FA9DE094-62E5-4B4E-A75D-13C1D1CC2E98}"/>
              </a:ext>
            </a:extLst>
          </p:cNvPr>
          <p:cNvCxnSpPr>
            <a:cxnSpLocks/>
          </p:cNvCxnSpPr>
          <p:nvPr/>
        </p:nvCxnSpPr>
        <p:spPr>
          <a:xfrm>
            <a:off x="6680902" y="3593054"/>
            <a:ext cx="0" cy="664214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0DAE8C7C-AFA0-404F-9C73-894CA2EF8CA2}"/>
              </a:ext>
            </a:extLst>
          </p:cNvPr>
          <p:cNvCxnSpPr>
            <a:cxnSpLocks/>
          </p:cNvCxnSpPr>
          <p:nvPr/>
        </p:nvCxnSpPr>
        <p:spPr>
          <a:xfrm>
            <a:off x="7976302" y="3588764"/>
            <a:ext cx="0" cy="380962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EBB3B54B-2928-B849-954C-75F923576F11}"/>
              </a:ext>
            </a:extLst>
          </p:cNvPr>
          <p:cNvSpPr txBox="1"/>
          <p:nvPr/>
        </p:nvSpPr>
        <p:spPr>
          <a:xfrm>
            <a:off x="2673089" y="3422119"/>
            <a:ext cx="3417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&amp;&amp;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1B3F32B-3CC5-8E47-8662-27272D672100}"/>
              </a:ext>
            </a:extLst>
          </p:cNvPr>
          <p:cNvSpPr txBox="1"/>
          <p:nvPr/>
        </p:nvSpPr>
        <p:spPr>
          <a:xfrm>
            <a:off x="3955965" y="3422119"/>
            <a:ext cx="3417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&amp;&amp;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8769CF94-8BA8-F049-A436-3245649EC5EF}"/>
              </a:ext>
            </a:extLst>
          </p:cNvPr>
          <p:cNvSpPr txBox="1"/>
          <p:nvPr/>
        </p:nvSpPr>
        <p:spPr>
          <a:xfrm>
            <a:off x="5100367" y="3394411"/>
            <a:ext cx="5774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&amp;&amp;&amp;&amp;&amp;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255D70E5-C54D-C247-9F53-1B9DAE4AA3E1}"/>
              </a:ext>
            </a:extLst>
          </p:cNvPr>
          <p:cNvSpPr txBox="1"/>
          <p:nvPr/>
        </p:nvSpPr>
        <p:spPr>
          <a:xfrm>
            <a:off x="6392201" y="3405411"/>
            <a:ext cx="5774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&amp;&amp;&amp;&amp;&amp;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5E729744-8507-7145-8423-8E3C0271E496}"/>
              </a:ext>
            </a:extLst>
          </p:cNvPr>
          <p:cNvSpPr txBox="1"/>
          <p:nvPr/>
        </p:nvSpPr>
        <p:spPr>
          <a:xfrm>
            <a:off x="7783372" y="3414577"/>
            <a:ext cx="3417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&amp;&amp;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FED215D-C672-4D54-B0B0-1E135E6A0E0F}"/>
              </a:ext>
            </a:extLst>
          </p:cNvPr>
          <p:cNvSpPr txBox="1"/>
          <p:nvPr/>
        </p:nvSpPr>
        <p:spPr>
          <a:xfrm>
            <a:off x="1039548" y="2077619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Baseline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BFB6304-ED40-449A-A9C4-B41D05DE57D4}"/>
              </a:ext>
            </a:extLst>
          </p:cNvPr>
          <p:cNvSpPr txBox="1"/>
          <p:nvPr/>
        </p:nvSpPr>
        <p:spPr>
          <a:xfrm>
            <a:off x="1428764" y="207761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4 </a:t>
            </a:r>
            <a:r>
              <a:rPr lang="en-US" sz="700" dirty="0" err="1"/>
              <a:t>Hr</a:t>
            </a:r>
            <a:endParaRPr lang="en-US" sz="7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81CC08F2-E135-4C83-B5C3-273C14136610}"/>
              </a:ext>
            </a:extLst>
          </p:cNvPr>
          <p:cNvSpPr txBox="1"/>
          <p:nvPr/>
        </p:nvSpPr>
        <p:spPr>
          <a:xfrm>
            <a:off x="2447039" y="207761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4 Day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3F355E77-2B46-4F7F-B68E-8492233FFD96}"/>
              </a:ext>
            </a:extLst>
          </p:cNvPr>
          <p:cNvSpPr txBox="1"/>
          <p:nvPr/>
        </p:nvSpPr>
        <p:spPr>
          <a:xfrm>
            <a:off x="2772020" y="207761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4 </a:t>
            </a:r>
            <a:r>
              <a:rPr lang="en-US" sz="700" dirty="0" err="1"/>
              <a:t>Hr</a:t>
            </a:r>
            <a:endParaRPr lang="en-US" sz="700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F720DC07-1067-43D8-8918-8C019C4199BD}"/>
              </a:ext>
            </a:extLst>
          </p:cNvPr>
          <p:cNvSpPr txBox="1"/>
          <p:nvPr/>
        </p:nvSpPr>
        <p:spPr>
          <a:xfrm>
            <a:off x="3695045" y="207761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4 Day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6F981DE3-B72A-42E4-B5E9-78007EFE7866}"/>
              </a:ext>
            </a:extLst>
          </p:cNvPr>
          <p:cNvSpPr txBox="1"/>
          <p:nvPr/>
        </p:nvSpPr>
        <p:spPr>
          <a:xfrm>
            <a:off x="4049083" y="207761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4 </a:t>
            </a:r>
            <a:r>
              <a:rPr lang="en-US" sz="700" dirty="0" err="1"/>
              <a:t>Hr</a:t>
            </a:r>
            <a:endParaRPr lang="en-US" sz="70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BF5926A0-C194-4418-90BE-E9D83400EE74}"/>
              </a:ext>
            </a:extLst>
          </p:cNvPr>
          <p:cNvSpPr txBox="1"/>
          <p:nvPr/>
        </p:nvSpPr>
        <p:spPr>
          <a:xfrm>
            <a:off x="4905433" y="207761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4 Day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61979FF6-3217-4EA3-B1AB-0925F41C08D3}"/>
              </a:ext>
            </a:extLst>
          </p:cNvPr>
          <p:cNvSpPr txBox="1"/>
          <p:nvPr/>
        </p:nvSpPr>
        <p:spPr>
          <a:xfrm>
            <a:off x="5252494" y="207761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4 </a:t>
            </a:r>
            <a:r>
              <a:rPr lang="en-US" sz="700" dirty="0" err="1"/>
              <a:t>Hr</a:t>
            </a:r>
            <a:endParaRPr lang="en-US" sz="700" dirty="0"/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7982A700-D194-4E66-B3B5-1FF08676542A}"/>
              </a:ext>
            </a:extLst>
          </p:cNvPr>
          <p:cNvSpPr txBox="1"/>
          <p:nvPr/>
        </p:nvSpPr>
        <p:spPr>
          <a:xfrm>
            <a:off x="6108844" y="207761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4 Day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3059DD28-9296-4770-98F8-86ED909FB01D}"/>
              </a:ext>
            </a:extLst>
          </p:cNvPr>
          <p:cNvSpPr txBox="1"/>
          <p:nvPr/>
        </p:nvSpPr>
        <p:spPr>
          <a:xfrm>
            <a:off x="6498390" y="207761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4 </a:t>
            </a:r>
            <a:r>
              <a:rPr lang="en-US" sz="700" dirty="0" err="1"/>
              <a:t>Hr</a:t>
            </a:r>
            <a:endParaRPr lang="en-US" sz="700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CB3F68F-C7BF-4C5C-A0CD-BF6DC0CF5929}"/>
              </a:ext>
            </a:extLst>
          </p:cNvPr>
          <p:cNvSpPr txBox="1"/>
          <p:nvPr/>
        </p:nvSpPr>
        <p:spPr>
          <a:xfrm>
            <a:off x="7354740" y="207761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4 Day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27B7A89F-8204-40EE-A0E0-EE3442421813}"/>
              </a:ext>
            </a:extLst>
          </p:cNvPr>
          <p:cNvSpPr txBox="1"/>
          <p:nvPr/>
        </p:nvSpPr>
        <p:spPr>
          <a:xfrm>
            <a:off x="7728164" y="2077619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4 </a:t>
            </a:r>
            <a:r>
              <a:rPr lang="en-US" sz="700" dirty="0" err="1"/>
              <a:t>Hr</a:t>
            </a:r>
            <a:endParaRPr lang="en-US" sz="700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42D111B3-9EA6-4C65-A435-674FEFFA283C}"/>
              </a:ext>
            </a:extLst>
          </p:cNvPr>
          <p:cNvSpPr txBox="1"/>
          <p:nvPr/>
        </p:nvSpPr>
        <p:spPr>
          <a:xfrm>
            <a:off x="8679764" y="2077619"/>
            <a:ext cx="4331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4 Day</a:t>
            </a:r>
          </a:p>
        </p:txBody>
      </p:sp>
    </p:spTree>
    <p:extLst>
      <p:ext uri="{BB962C8B-B14F-4D97-AF65-F5344CB8AC3E}">
        <p14:creationId xmlns:p14="http://schemas.microsoft.com/office/powerpoint/2010/main" val="3120591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105</Words>
  <Application>Microsoft Office PowerPoint</Application>
  <PresentationFormat>Widescreen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gler-Chiurazzi, Elizabeth B</dc:creator>
  <cp:lastModifiedBy>Engler-Chiurazzi, Elizabeth B</cp:lastModifiedBy>
  <cp:revision>8</cp:revision>
  <dcterms:created xsi:type="dcterms:W3CDTF">2022-03-07T22:33:08Z</dcterms:created>
  <dcterms:modified xsi:type="dcterms:W3CDTF">2022-03-15T17:51:21Z</dcterms:modified>
</cp:coreProperties>
</file>